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8D6858-B5CF-4CC7-A77A-E28314D0FCC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23E43A-3915-4967-B3C1-44B3037769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E2024E-1BAE-4E69-A6DD-4642822C8DA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B1D08A-FC60-4CA7-83AF-974591D8411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B30EA2-CD60-4F16-9F3D-D12265F2C8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88EDE4-FDED-4BB6-9AF9-5D962EEF05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EC4D52-FC30-496A-80FE-F5A6B9F638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06D994-0789-4791-860D-DD4FC6EEAD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1A19A8-79F8-4E1C-AA84-C936663460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7D3A2F-4495-4652-9576-B28EBAC0C5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AA5582-35C1-49F5-8C8C-72E63154E8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57D6B6-2C5B-4FCF-B1D1-062FEC5850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3914E9-1893-4753-8270-87589A99E7C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720800" y="2787480"/>
            <a:ext cx="725400" cy="212760"/>
          </a:xfrm>
          <a:custGeom>
            <a:avLst/>
            <a:gdLst/>
            <a:ahLst/>
            <a:rect l="l" t="t" r="r" b="b"/>
            <a:pathLst>
              <a:path w="2176" h="635">
                <a:moveTo>
                  <a:pt x="0" y="635"/>
                </a:moveTo>
                <a:lnTo>
                  <a:pt x="54" y="631"/>
                </a:lnTo>
                <a:lnTo>
                  <a:pt x="108" y="620"/>
                </a:lnTo>
                <a:lnTo>
                  <a:pt x="163" y="614"/>
                </a:lnTo>
                <a:lnTo>
                  <a:pt x="218" y="595"/>
                </a:lnTo>
                <a:lnTo>
                  <a:pt x="272" y="571"/>
                </a:lnTo>
                <a:lnTo>
                  <a:pt x="326" y="535"/>
                </a:lnTo>
                <a:lnTo>
                  <a:pt x="380" y="498"/>
                </a:lnTo>
                <a:lnTo>
                  <a:pt x="435" y="469"/>
                </a:lnTo>
                <a:lnTo>
                  <a:pt x="490" y="450"/>
                </a:lnTo>
                <a:lnTo>
                  <a:pt x="544" y="417"/>
                </a:lnTo>
                <a:lnTo>
                  <a:pt x="598" y="381"/>
                </a:lnTo>
                <a:lnTo>
                  <a:pt x="652" y="357"/>
                </a:lnTo>
                <a:lnTo>
                  <a:pt x="707" y="354"/>
                </a:lnTo>
                <a:lnTo>
                  <a:pt x="762" y="359"/>
                </a:lnTo>
                <a:lnTo>
                  <a:pt x="816" y="357"/>
                </a:lnTo>
                <a:lnTo>
                  <a:pt x="870" y="350"/>
                </a:lnTo>
                <a:lnTo>
                  <a:pt x="924" y="329"/>
                </a:lnTo>
                <a:lnTo>
                  <a:pt x="979" y="305"/>
                </a:lnTo>
                <a:lnTo>
                  <a:pt x="1034" y="278"/>
                </a:lnTo>
                <a:lnTo>
                  <a:pt x="1088" y="251"/>
                </a:lnTo>
                <a:lnTo>
                  <a:pt x="1142" y="236"/>
                </a:lnTo>
                <a:lnTo>
                  <a:pt x="1196" y="226"/>
                </a:lnTo>
                <a:lnTo>
                  <a:pt x="1251" y="232"/>
                </a:lnTo>
                <a:lnTo>
                  <a:pt x="1306" y="224"/>
                </a:lnTo>
                <a:lnTo>
                  <a:pt x="1360" y="199"/>
                </a:lnTo>
                <a:lnTo>
                  <a:pt x="1414" y="178"/>
                </a:lnTo>
                <a:lnTo>
                  <a:pt x="1468" y="169"/>
                </a:lnTo>
                <a:lnTo>
                  <a:pt x="1523" y="163"/>
                </a:lnTo>
                <a:lnTo>
                  <a:pt x="1578" y="149"/>
                </a:lnTo>
                <a:lnTo>
                  <a:pt x="1632" y="126"/>
                </a:lnTo>
                <a:lnTo>
                  <a:pt x="1686" y="112"/>
                </a:lnTo>
                <a:lnTo>
                  <a:pt x="1740" y="99"/>
                </a:lnTo>
                <a:lnTo>
                  <a:pt x="1795" y="103"/>
                </a:lnTo>
                <a:lnTo>
                  <a:pt x="1850" y="103"/>
                </a:lnTo>
                <a:lnTo>
                  <a:pt x="1904" y="97"/>
                </a:lnTo>
                <a:lnTo>
                  <a:pt x="1958" y="78"/>
                </a:lnTo>
                <a:lnTo>
                  <a:pt x="2012" y="64"/>
                </a:lnTo>
                <a:lnTo>
                  <a:pt x="2067" y="45"/>
                </a:lnTo>
                <a:lnTo>
                  <a:pt x="2122" y="27"/>
                </a:lnTo>
                <a:lnTo>
                  <a:pt x="2176" y="0"/>
                </a:lnTo>
              </a:path>
            </a:pathLst>
          </a:custGeom>
          <a:noFill/>
          <a:ln w="19080">
            <a:solidFill>
              <a:srgbClr val="00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690560" y="549360"/>
            <a:ext cx="1814760" cy="1025280"/>
          </a:xfrm>
          <a:prstGeom prst="rect">
            <a:avLst/>
          </a:prstGeom>
          <a:noFill/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690560" y="1574640"/>
            <a:ext cx="1800" cy="2232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052720" y="1574640"/>
            <a:ext cx="1440" cy="2232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416320" y="1574640"/>
            <a:ext cx="1440" cy="2232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779560" y="1574640"/>
            <a:ext cx="1800" cy="2232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141720" y="1574640"/>
            <a:ext cx="1440" cy="2232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505320" y="1574640"/>
            <a:ext cx="1440" cy="2232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flipH="1">
            <a:off x="1666800" y="1574640"/>
            <a:ext cx="23760" cy="180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flipH="1">
            <a:off x="1677600" y="1370160"/>
            <a:ext cx="12600" cy="14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flipH="1">
            <a:off x="1677600" y="1165320"/>
            <a:ext cx="12600" cy="14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flipH="1">
            <a:off x="1677600" y="960480"/>
            <a:ext cx="12600" cy="14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H="1">
            <a:off x="1677600" y="754200"/>
            <a:ext cx="12600" cy="14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H="1">
            <a:off x="1666800" y="549360"/>
            <a:ext cx="23760" cy="14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690560" y="3714840"/>
            <a:ext cx="1814760" cy="1028520"/>
          </a:xfrm>
          <a:prstGeom prst="rect">
            <a:avLst/>
          </a:prstGeom>
          <a:noFill/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690560" y="4743360"/>
            <a:ext cx="1800" cy="1908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052720" y="4743360"/>
            <a:ext cx="1440" cy="1908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416320" y="4743360"/>
            <a:ext cx="1440" cy="1908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779560" y="4743360"/>
            <a:ext cx="1800" cy="1908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141720" y="4743360"/>
            <a:ext cx="1440" cy="1908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505320" y="4743360"/>
            <a:ext cx="1440" cy="1908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H="1">
            <a:off x="1666800" y="4743360"/>
            <a:ext cx="2376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H="1">
            <a:off x="1677600" y="4535640"/>
            <a:ext cx="12600" cy="14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flipH="1">
            <a:off x="1677600" y="4332240"/>
            <a:ext cx="1260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flipH="1">
            <a:off x="1677600" y="4125960"/>
            <a:ext cx="12600" cy="14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flipH="1">
            <a:off x="1677600" y="3922560"/>
            <a:ext cx="1260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flipH="1">
            <a:off x="1666800" y="3714840"/>
            <a:ext cx="23760" cy="14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690560" y="5083200"/>
            <a:ext cx="1814760" cy="1025640"/>
          </a:xfrm>
          <a:prstGeom prst="rect">
            <a:avLst/>
          </a:prstGeom>
          <a:noFill/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690560" y="6108840"/>
            <a:ext cx="1800" cy="2052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052720" y="6108840"/>
            <a:ext cx="1440" cy="2052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416320" y="6108840"/>
            <a:ext cx="1440" cy="2052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779560" y="6108840"/>
            <a:ext cx="1800" cy="2052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141720" y="6108840"/>
            <a:ext cx="1440" cy="2052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505320" y="6108840"/>
            <a:ext cx="1440" cy="2052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flipH="1">
            <a:off x="1666800" y="6108840"/>
            <a:ext cx="23760" cy="14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H="1">
            <a:off x="1677600" y="5904000"/>
            <a:ext cx="12600" cy="14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flipH="1">
            <a:off x="1677600" y="5699160"/>
            <a:ext cx="1260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flipH="1">
            <a:off x="1677600" y="5494320"/>
            <a:ext cx="12600" cy="14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flipH="1">
            <a:off x="1677600" y="5288040"/>
            <a:ext cx="12600" cy="14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flipH="1">
            <a:off x="1666800" y="5083200"/>
            <a:ext cx="23760" cy="14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703520" y="2268360"/>
            <a:ext cx="1814400" cy="1025640"/>
          </a:xfrm>
          <a:prstGeom prst="rect">
            <a:avLst/>
          </a:prstGeom>
          <a:noFill/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065320" y="3294000"/>
            <a:ext cx="1440" cy="2088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428920" y="3294000"/>
            <a:ext cx="1440" cy="2088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2792520" y="3294000"/>
            <a:ext cx="0" cy="2088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3154320" y="3294000"/>
            <a:ext cx="1800" cy="2088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517920" y="3294000"/>
            <a:ext cx="1440" cy="2088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1720800" y="2765520"/>
            <a:ext cx="725400" cy="210960"/>
          </a:xfrm>
          <a:custGeom>
            <a:avLst/>
            <a:gdLst/>
            <a:ahLst/>
            <a:rect l="l" t="t" r="r" b="b"/>
            <a:pathLst>
              <a:path w="2176" h="631">
                <a:moveTo>
                  <a:pt x="0" y="631"/>
                </a:moveTo>
                <a:lnTo>
                  <a:pt x="54" y="598"/>
                </a:lnTo>
                <a:lnTo>
                  <a:pt x="108" y="565"/>
                </a:lnTo>
                <a:lnTo>
                  <a:pt x="163" y="529"/>
                </a:lnTo>
                <a:lnTo>
                  <a:pt x="218" y="517"/>
                </a:lnTo>
                <a:lnTo>
                  <a:pt x="272" y="490"/>
                </a:lnTo>
                <a:lnTo>
                  <a:pt x="326" y="477"/>
                </a:lnTo>
                <a:lnTo>
                  <a:pt x="380" y="453"/>
                </a:lnTo>
                <a:lnTo>
                  <a:pt x="435" y="438"/>
                </a:lnTo>
                <a:lnTo>
                  <a:pt x="490" y="419"/>
                </a:lnTo>
                <a:lnTo>
                  <a:pt x="544" y="398"/>
                </a:lnTo>
                <a:lnTo>
                  <a:pt x="598" y="378"/>
                </a:lnTo>
                <a:lnTo>
                  <a:pt x="652" y="353"/>
                </a:lnTo>
                <a:lnTo>
                  <a:pt x="707" y="336"/>
                </a:lnTo>
                <a:lnTo>
                  <a:pt x="762" y="320"/>
                </a:lnTo>
                <a:lnTo>
                  <a:pt x="816" y="305"/>
                </a:lnTo>
                <a:lnTo>
                  <a:pt x="870" y="302"/>
                </a:lnTo>
                <a:lnTo>
                  <a:pt x="924" y="296"/>
                </a:lnTo>
                <a:lnTo>
                  <a:pt x="979" y="290"/>
                </a:lnTo>
                <a:lnTo>
                  <a:pt x="1034" y="274"/>
                </a:lnTo>
                <a:lnTo>
                  <a:pt x="1088" y="257"/>
                </a:lnTo>
                <a:lnTo>
                  <a:pt x="1142" y="251"/>
                </a:lnTo>
                <a:lnTo>
                  <a:pt x="1196" y="236"/>
                </a:lnTo>
                <a:lnTo>
                  <a:pt x="1251" y="226"/>
                </a:lnTo>
                <a:lnTo>
                  <a:pt x="1306" y="214"/>
                </a:lnTo>
                <a:lnTo>
                  <a:pt x="1360" y="203"/>
                </a:lnTo>
                <a:lnTo>
                  <a:pt x="1414" y="193"/>
                </a:lnTo>
                <a:lnTo>
                  <a:pt x="1468" y="181"/>
                </a:lnTo>
                <a:lnTo>
                  <a:pt x="1523" y="170"/>
                </a:lnTo>
                <a:lnTo>
                  <a:pt x="1578" y="151"/>
                </a:lnTo>
                <a:lnTo>
                  <a:pt x="1632" y="118"/>
                </a:lnTo>
                <a:lnTo>
                  <a:pt x="1686" y="99"/>
                </a:lnTo>
                <a:lnTo>
                  <a:pt x="1740" y="75"/>
                </a:lnTo>
                <a:lnTo>
                  <a:pt x="1795" y="72"/>
                </a:lnTo>
                <a:lnTo>
                  <a:pt x="1850" y="70"/>
                </a:lnTo>
                <a:lnTo>
                  <a:pt x="1904" y="70"/>
                </a:lnTo>
                <a:lnTo>
                  <a:pt x="1958" y="64"/>
                </a:lnTo>
                <a:lnTo>
                  <a:pt x="2012" y="64"/>
                </a:lnTo>
                <a:lnTo>
                  <a:pt x="2067" y="58"/>
                </a:lnTo>
                <a:lnTo>
                  <a:pt x="2122" y="37"/>
                </a:lnTo>
                <a:lnTo>
                  <a:pt x="2176" y="0"/>
                </a:lnTo>
              </a:path>
            </a:pathLst>
          </a:custGeom>
          <a:noFill/>
          <a:ln w="19080">
            <a:solidFill>
              <a:srgbClr val="96969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708200" y="3768840"/>
            <a:ext cx="1106280" cy="577800"/>
          </a:xfrm>
          <a:custGeom>
            <a:avLst/>
            <a:gdLst/>
            <a:ahLst/>
            <a:rect l="l" t="t" r="r" b="b"/>
            <a:pathLst>
              <a:path w="3318" h="1732">
                <a:moveTo>
                  <a:pt x="0" y="1732"/>
                </a:moveTo>
                <a:lnTo>
                  <a:pt x="54" y="1641"/>
                </a:lnTo>
                <a:lnTo>
                  <a:pt x="109" y="1526"/>
                </a:lnTo>
                <a:lnTo>
                  <a:pt x="163" y="1399"/>
                </a:lnTo>
                <a:lnTo>
                  <a:pt x="218" y="1314"/>
                </a:lnTo>
                <a:lnTo>
                  <a:pt x="272" y="1242"/>
                </a:lnTo>
                <a:lnTo>
                  <a:pt x="326" y="1179"/>
                </a:lnTo>
                <a:lnTo>
                  <a:pt x="381" y="1103"/>
                </a:lnTo>
                <a:lnTo>
                  <a:pt x="435" y="1043"/>
                </a:lnTo>
                <a:lnTo>
                  <a:pt x="490" y="988"/>
                </a:lnTo>
                <a:lnTo>
                  <a:pt x="544" y="934"/>
                </a:lnTo>
                <a:lnTo>
                  <a:pt x="598" y="889"/>
                </a:lnTo>
                <a:lnTo>
                  <a:pt x="652" y="855"/>
                </a:lnTo>
                <a:lnTo>
                  <a:pt x="707" y="831"/>
                </a:lnTo>
                <a:lnTo>
                  <a:pt x="762" y="785"/>
                </a:lnTo>
                <a:lnTo>
                  <a:pt x="816" y="729"/>
                </a:lnTo>
                <a:lnTo>
                  <a:pt x="870" y="671"/>
                </a:lnTo>
                <a:lnTo>
                  <a:pt x="924" y="641"/>
                </a:lnTo>
                <a:lnTo>
                  <a:pt x="979" y="617"/>
                </a:lnTo>
                <a:lnTo>
                  <a:pt x="1034" y="598"/>
                </a:lnTo>
                <a:lnTo>
                  <a:pt x="1088" y="571"/>
                </a:lnTo>
                <a:lnTo>
                  <a:pt x="1142" y="553"/>
                </a:lnTo>
                <a:lnTo>
                  <a:pt x="1196" y="529"/>
                </a:lnTo>
                <a:lnTo>
                  <a:pt x="1251" y="499"/>
                </a:lnTo>
                <a:lnTo>
                  <a:pt x="1306" y="463"/>
                </a:lnTo>
                <a:lnTo>
                  <a:pt x="1360" y="441"/>
                </a:lnTo>
                <a:lnTo>
                  <a:pt x="1414" y="424"/>
                </a:lnTo>
                <a:lnTo>
                  <a:pt x="1468" y="399"/>
                </a:lnTo>
                <a:lnTo>
                  <a:pt x="1523" y="372"/>
                </a:lnTo>
                <a:lnTo>
                  <a:pt x="1578" y="339"/>
                </a:lnTo>
                <a:lnTo>
                  <a:pt x="1632" y="324"/>
                </a:lnTo>
                <a:lnTo>
                  <a:pt x="1686" y="305"/>
                </a:lnTo>
                <a:lnTo>
                  <a:pt x="1740" y="293"/>
                </a:lnTo>
                <a:lnTo>
                  <a:pt x="1795" y="285"/>
                </a:lnTo>
                <a:lnTo>
                  <a:pt x="1850" y="275"/>
                </a:lnTo>
                <a:lnTo>
                  <a:pt x="1904" y="260"/>
                </a:lnTo>
                <a:lnTo>
                  <a:pt x="1958" y="233"/>
                </a:lnTo>
                <a:lnTo>
                  <a:pt x="2012" y="214"/>
                </a:lnTo>
                <a:lnTo>
                  <a:pt x="2067" y="193"/>
                </a:lnTo>
                <a:lnTo>
                  <a:pt x="2122" y="185"/>
                </a:lnTo>
                <a:lnTo>
                  <a:pt x="2176" y="173"/>
                </a:lnTo>
                <a:lnTo>
                  <a:pt x="2230" y="169"/>
                </a:lnTo>
                <a:lnTo>
                  <a:pt x="2284" y="158"/>
                </a:lnTo>
                <a:lnTo>
                  <a:pt x="2339" y="148"/>
                </a:lnTo>
                <a:lnTo>
                  <a:pt x="2394" y="139"/>
                </a:lnTo>
                <a:lnTo>
                  <a:pt x="2448" y="145"/>
                </a:lnTo>
                <a:lnTo>
                  <a:pt x="2502" y="148"/>
                </a:lnTo>
                <a:lnTo>
                  <a:pt x="2556" y="152"/>
                </a:lnTo>
                <a:lnTo>
                  <a:pt x="2611" y="142"/>
                </a:lnTo>
                <a:lnTo>
                  <a:pt x="2666" y="136"/>
                </a:lnTo>
                <a:lnTo>
                  <a:pt x="2720" y="115"/>
                </a:lnTo>
                <a:lnTo>
                  <a:pt x="2774" y="97"/>
                </a:lnTo>
                <a:lnTo>
                  <a:pt x="2828" y="85"/>
                </a:lnTo>
                <a:lnTo>
                  <a:pt x="2883" y="85"/>
                </a:lnTo>
                <a:lnTo>
                  <a:pt x="2938" y="88"/>
                </a:lnTo>
                <a:lnTo>
                  <a:pt x="2992" y="79"/>
                </a:lnTo>
                <a:lnTo>
                  <a:pt x="3046" y="61"/>
                </a:lnTo>
                <a:lnTo>
                  <a:pt x="3100" y="46"/>
                </a:lnTo>
                <a:lnTo>
                  <a:pt x="3155" y="36"/>
                </a:lnTo>
                <a:lnTo>
                  <a:pt x="3210" y="27"/>
                </a:lnTo>
                <a:lnTo>
                  <a:pt x="3264" y="15"/>
                </a:lnTo>
                <a:lnTo>
                  <a:pt x="3318" y="0"/>
                </a:lnTo>
              </a:path>
            </a:pathLst>
          </a:custGeom>
          <a:noFill/>
          <a:ln w="19080">
            <a:solidFill>
              <a:srgbClr val="96969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708200" y="3746520"/>
            <a:ext cx="1106280" cy="603360"/>
          </a:xfrm>
          <a:custGeom>
            <a:avLst/>
            <a:gdLst/>
            <a:ahLst/>
            <a:rect l="l" t="t" r="r" b="b"/>
            <a:pathLst>
              <a:path w="3318" h="1812">
                <a:moveTo>
                  <a:pt x="0" y="1812"/>
                </a:moveTo>
                <a:lnTo>
                  <a:pt x="54" y="1689"/>
                </a:lnTo>
                <a:lnTo>
                  <a:pt x="109" y="1556"/>
                </a:lnTo>
                <a:lnTo>
                  <a:pt x="163" y="1435"/>
                </a:lnTo>
                <a:lnTo>
                  <a:pt x="218" y="1347"/>
                </a:lnTo>
                <a:lnTo>
                  <a:pt x="272" y="1275"/>
                </a:lnTo>
                <a:lnTo>
                  <a:pt x="326" y="1214"/>
                </a:lnTo>
                <a:lnTo>
                  <a:pt x="381" y="1142"/>
                </a:lnTo>
                <a:lnTo>
                  <a:pt x="435" y="1063"/>
                </a:lnTo>
                <a:lnTo>
                  <a:pt x="490" y="984"/>
                </a:lnTo>
                <a:lnTo>
                  <a:pt x="544" y="918"/>
                </a:lnTo>
                <a:lnTo>
                  <a:pt x="598" y="845"/>
                </a:lnTo>
                <a:lnTo>
                  <a:pt x="652" y="776"/>
                </a:lnTo>
                <a:lnTo>
                  <a:pt x="707" y="704"/>
                </a:lnTo>
                <a:lnTo>
                  <a:pt x="762" y="664"/>
                </a:lnTo>
                <a:lnTo>
                  <a:pt x="816" y="619"/>
                </a:lnTo>
                <a:lnTo>
                  <a:pt x="870" y="602"/>
                </a:lnTo>
                <a:lnTo>
                  <a:pt x="924" y="571"/>
                </a:lnTo>
                <a:lnTo>
                  <a:pt x="979" y="540"/>
                </a:lnTo>
                <a:lnTo>
                  <a:pt x="1034" y="498"/>
                </a:lnTo>
                <a:lnTo>
                  <a:pt x="1088" y="453"/>
                </a:lnTo>
                <a:lnTo>
                  <a:pt x="1142" y="417"/>
                </a:lnTo>
                <a:lnTo>
                  <a:pt x="1196" y="378"/>
                </a:lnTo>
                <a:lnTo>
                  <a:pt x="1251" y="353"/>
                </a:lnTo>
                <a:lnTo>
                  <a:pt x="1306" y="332"/>
                </a:lnTo>
                <a:lnTo>
                  <a:pt x="1360" y="323"/>
                </a:lnTo>
                <a:lnTo>
                  <a:pt x="1414" y="314"/>
                </a:lnTo>
                <a:lnTo>
                  <a:pt x="1468" y="303"/>
                </a:lnTo>
                <a:lnTo>
                  <a:pt x="1523" y="284"/>
                </a:lnTo>
                <a:lnTo>
                  <a:pt x="1578" y="263"/>
                </a:lnTo>
                <a:lnTo>
                  <a:pt x="1632" y="239"/>
                </a:lnTo>
                <a:lnTo>
                  <a:pt x="1686" y="214"/>
                </a:lnTo>
                <a:lnTo>
                  <a:pt x="1740" y="193"/>
                </a:lnTo>
                <a:lnTo>
                  <a:pt x="1795" y="187"/>
                </a:lnTo>
                <a:lnTo>
                  <a:pt x="1850" y="178"/>
                </a:lnTo>
                <a:lnTo>
                  <a:pt x="1904" y="175"/>
                </a:lnTo>
                <a:lnTo>
                  <a:pt x="1958" y="163"/>
                </a:lnTo>
                <a:lnTo>
                  <a:pt x="2012" y="147"/>
                </a:lnTo>
                <a:lnTo>
                  <a:pt x="2067" y="124"/>
                </a:lnTo>
                <a:lnTo>
                  <a:pt x="2122" y="102"/>
                </a:lnTo>
                <a:lnTo>
                  <a:pt x="2176" y="93"/>
                </a:lnTo>
                <a:lnTo>
                  <a:pt x="2230" y="93"/>
                </a:lnTo>
                <a:lnTo>
                  <a:pt x="2284" y="87"/>
                </a:lnTo>
                <a:lnTo>
                  <a:pt x="2339" y="81"/>
                </a:lnTo>
                <a:lnTo>
                  <a:pt x="2394" y="72"/>
                </a:lnTo>
                <a:lnTo>
                  <a:pt x="2448" y="64"/>
                </a:lnTo>
                <a:lnTo>
                  <a:pt x="2502" y="54"/>
                </a:lnTo>
                <a:lnTo>
                  <a:pt x="2556" y="51"/>
                </a:lnTo>
                <a:lnTo>
                  <a:pt x="2611" y="58"/>
                </a:lnTo>
                <a:lnTo>
                  <a:pt x="2666" y="58"/>
                </a:lnTo>
                <a:lnTo>
                  <a:pt x="2720" y="58"/>
                </a:lnTo>
                <a:lnTo>
                  <a:pt x="2774" y="42"/>
                </a:lnTo>
                <a:lnTo>
                  <a:pt x="2828" y="35"/>
                </a:lnTo>
                <a:lnTo>
                  <a:pt x="2883" y="33"/>
                </a:lnTo>
                <a:lnTo>
                  <a:pt x="2938" y="39"/>
                </a:lnTo>
                <a:lnTo>
                  <a:pt x="2992" y="42"/>
                </a:lnTo>
                <a:lnTo>
                  <a:pt x="3046" y="35"/>
                </a:lnTo>
                <a:lnTo>
                  <a:pt x="3100" y="21"/>
                </a:lnTo>
                <a:lnTo>
                  <a:pt x="3155" y="8"/>
                </a:lnTo>
                <a:lnTo>
                  <a:pt x="3210" y="2"/>
                </a:lnTo>
                <a:lnTo>
                  <a:pt x="3264" y="0"/>
                </a:lnTo>
                <a:lnTo>
                  <a:pt x="3318" y="0"/>
                </a:lnTo>
              </a:path>
            </a:pathLst>
          </a:custGeom>
          <a:noFill/>
          <a:ln w="19080">
            <a:solidFill>
              <a:srgbClr val="ff33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1708200" y="3719520"/>
            <a:ext cx="1106280" cy="630360"/>
          </a:xfrm>
          <a:custGeom>
            <a:avLst/>
            <a:gdLst/>
            <a:ahLst/>
            <a:rect l="l" t="t" r="r" b="b"/>
            <a:pathLst>
              <a:path w="3318" h="1893">
                <a:moveTo>
                  <a:pt x="0" y="1893"/>
                </a:moveTo>
                <a:lnTo>
                  <a:pt x="54" y="1676"/>
                </a:lnTo>
                <a:lnTo>
                  <a:pt x="109" y="1474"/>
                </a:lnTo>
                <a:lnTo>
                  <a:pt x="163" y="1283"/>
                </a:lnTo>
                <a:lnTo>
                  <a:pt x="218" y="1162"/>
                </a:lnTo>
                <a:lnTo>
                  <a:pt x="272" y="1075"/>
                </a:lnTo>
                <a:lnTo>
                  <a:pt x="326" y="1015"/>
                </a:lnTo>
                <a:lnTo>
                  <a:pt x="381" y="930"/>
                </a:lnTo>
                <a:lnTo>
                  <a:pt x="435" y="851"/>
                </a:lnTo>
                <a:lnTo>
                  <a:pt x="490" y="779"/>
                </a:lnTo>
                <a:lnTo>
                  <a:pt x="544" y="727"/>
                </a:lnTo>
                <a:lnTo>
                  <a:pt x="598" y="664"/>
                </a:lnTo>
                <a:lnTo>
                  <a:pt x="652" y="604"/>
                </a:lnTo>
                <a:lnTo>
                  <a:pt x="707" y="527"/>
                </a:lnTo>
                <a:lnTo>
                  <a:pt x="762" y="473"/>
                </a:lnTo>
                <a:lnTo>
                  <a:pt x="816" y="425"/>
                </a:lnTo>
                <a:lnTo>
                  <a:pt x="870" y="398"/>
                </a:lnTo>
                <a:lnTo>
                  <a:pt x="924" y="365"/>
                </a:lnTo>
                <a:lnTo>
                  <a:pt x="979" y="334"/>
                </a:lnTo>
                <a:lnTo>
                  <a:pt x="1034" y="305"/>
                </a:lnTo>
                <a:lnTo>
                  <a:pt x="1088" y="278"/>
                </a:lnTo>
                <a:lnTo>
                  <a:pt x="1142" y="253"/>
                </a:lnTo>
                <a:lnTo>
                  <a:pt x="1196" y="222"/>
                </a:lnTo>
                <a:lnTo>
                  <a:pt x="1251" y="201"/>
                </a:lnTo>
                <a:lnTo>
                  <a:pt x="1306" y="180"/>
                </a:lnTo>
                <a:lnTo>
                  <a:pt x="1360" y="174"/>
                </a:lnTo>
                <a:lnTo>
                  <a:pt x="1414" y="160"/>
                </a:lnTo>
                <a:lnTo>
                  <a:pt x="1468" y="156"/>
                </a:lnTo>
                <a:lnTo>
                  <a:pt x="1523" y="150"/>
                </a:lnTo>
                <a:lnTo>
                  <a:pt x="1578" y="150"/>
                </a:lnTo>
                <a:lnTo>
                  <a:pt x="1632" y="141"/>
                </a:lnTo>
                <a:lnTo>
                  <a:pt x="1686" y="123"/>
                </a:lnTo>
                <a:lnTo>
                  <a:pt x="1740" y="102"/>
                </a:lnTo>
                <a:lnTo>
                  <a:pt x="1795" y="87"/>
                </a:lnTo>
                <a:lnTo>
                  <a:pt x="1850" y="75"/>
                </a:lnTo>
                <a:lnTo>
                  <a:pt x="1904" y="72"/>
                </a:lnTo>
                <a:lnTo>
                  <a:pt x="1958" y="68"/>
                </a:lnTo>
                <a:lnTo>
                  <a:pt x="2012" y="62"/>
                </a:lnTo>
                <a:lnTo>
                  <a:pt x="2067" y="50"/>
                </a:lnTo>
                <a:lnTo>
                  <a:pt x="2122" y="41"/>
                </a:lnTo>
                <a:lnTo>
                  <a:pt x="2176" y="33"/>
                </a:lnTo>
                <a:lnTo>
                  <a:pt x="2230" y="33"/>
                </a:lnTo>
                <a:lnTo>
                  <a:pt x="2284" y="35"/>
                </a:lnTo>
                <a:lnTo>
                  <a:pt x="2339" y="35"/>
                </a:lnTo>
                <a:lnTo>
                  <a:pt x="2394" y="33"/>
                </a:lnTo>
                <a:lnTo>
                  <a:pt x="2448" y="27"/>
                </a:lnTo>
                <a:lnTo>
                  <a:pt x="2502" y="27"/>
                </a:lnTo>
                <a:lnTo>
                  <a:pt x="2556" y="27"/>
                </a:lnTo>
                <a:lnTo>
                  <a:pt x="2611" y="29"/>
                </a:lnTo>
                <a:lnTo>
                  <a:pt x="2666" y="27"/>
                </a:lnTo>
                <a:lnTo>
                  <a:pt x="2720" y="21"/>
                </a:lnTo>
                <a:lnTo>
                  <a:pt x="2774" y="17"/>
                </a:lnTo>
                <a:lnTo>
                  <a:pt x="2828" y="11"/>
                </a:lnTo>
                <a:lnTo>
                  <a:pt x="2883" y="11"/>
                </a:lnTo>
                <a:lnTo>
                  <a:pt x="2938" y="8"/>
                </a:lnTo>
                <a:lnTo>
                  <a:pt x="2992" y="6"/>
                </a:lnTo>
                <a:lnTo>
                  <a:pt x="3046" y="2"/>
                </a:lnTo>
                <a:lnTo>
                  <a:pt x="3100" y="2"/>
                </a:lnTo>
                <a:lnTo>
                  <a:pt x="3155" y="6"/>
                </a:lnTo>
                <a:lnTo>
                  <a:pt x="3210" y="6"/>
                </a:lnTo>
                <a:lnTo>
                  <a:pt x="3264" y="2"/>
                </a:lnTo>
                <a:lnTo>
                  <a:pt x="3318" y="0"/>
                </a:lnTo>
              </a:path>
            </a:pathLst>
          </a:custGeom>
          <a:noFill/>
          <a:ln w="19080">
            <a:solidFill>
              <a:srgbClr val="00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1708200" y="550800"/>
            <a:ext cx="1797120" cy="587520"/>
          </a:xfrm>
          <a:custGeom>
            <a:avLst/>
            <a:gdLst/>
            <a:ahLst/>
            <a:rect l="l" t="t" r="r" b="b"/>
            <a:pathLst>
              <a:path w="5386" h="1765">
                <a:moveTo>
                  <a:pt x="0" y="1765"/>
                </a:moveTo>
                <a:lnTo>
                  <a:pt x="54" y="1514"/>
                </a:lnTo>
                <a:lnTo>
                  <a:pt x="109" y="1320"/>
                </a:lnTo>
                <a:lnTo>
                  <a:pt x="163" y="1165"/>
                </a:lnTo>
                <a:lnTo>
                  <a:pt x="218" y="1055"/>
                </a:lnTo>
                <a:lnTo>
                  <a:pt x="272" y="943"/>
                </a:lnTo>
                <a:lnTo>
                  <a:pt x="326" y="843"/>
                </a:lnTo>
                <a:lnTo>
                  <a:pt x="381" y="746"/>
                </a:lnTo>
                <a:lnTo>
                  <a:pt x="435" y="667"/>
                </a:lnTo>
                <a:lnTo>
                  <a:pt x="490" y="613"/>
                </a:lnTo>
                <a:lnTo>
                  <a:pt x="544" y="577"/>
                </a:lnTo>
                <a:lnTo>
                  <a:pt x="598" y="544"/>
                </a:lnTo>
                <a:lnTo>
                  <a:pt x="652" y="501"/>
                </a:lnTo>
                <a:lnTo>
                  <a:pt x="707" y="455"/>
                </a:lnTo>
                <a:lnTo>
                  <a:pt x="762" y="414"/>
                </a:lnTo>
                <a:lnTo>
                  <a:pt x="816" y="377"/>
                </a:lnTo>
                <a:lnTo>
                  <a:pt x="870" y="341"/>
                </a:lnTo>
                <a:lnTo>
                  <a:pt x="924" y="310"/>
                </a:lnTo>
                <a:lnTo>
                  <a:pt x="979" y="283"/>
                </a:lnTo>
                <a:lnTo>
                  <a:pt x="1034" y="268"/>
                </a:lnTo>
                <a:lnTo>
                  <a:pt x="1088" y="254"/>
                </a:lnTo>
                <a:lnTo>
                  <a:pt x="1142" y="244"/>
                </a:lnTo>
                <a:lnTo>
                  <a:pt x="1196" y="233"/>
                </a:lnTo>
                <a:lnTo>
                  <a:pt x="1251" y="211"/>
                </a:lnTo>
                <a:lnTo>
                  <a:pt x="1306" y="187"/>
                </a:lnTo>
                <a:lnTo>
                  <a:pt x="1360" y="172"/>
                </a:lnTo>
                <a:lnTo>
                  <a:pt x="1414" y="156"/>
                </a:lnTo>
                <a:lnTo>
                  <a:pt x="1468" y="148"/>
                </a:lnTo>
                <a:lnTo>
                  <a:pt x="1523" y="139"/>
                </a:lnTo>
                <a:lnTo>
                  <a:pt x="1578" y="135"/>
                </a:lnTo>
                <a:lnTo>
                  <a:pt x="1632" y="129"/>
                </a:lnTo>
                <a:lnTo>
                  <a:pt x="1686" y="123"/>
                </a:lnTo>
                <a:lnTo>
                  <a:pt x="1740" y="115"/>
                </a:lnTo>
                <a:lnTo>
                  <a:pt x="1795" y="106"/>
                </a:lnTo>
                <a:lnTo>
                  <a:pt x="1850" y="96"/>
                </a:lnTo>
                <a:lnTo>
                  <a:pt x="1904" y="90"/>
                </a:lnTo>
                <a:lnTo>
                  <a:pt x="1958" y="84"/>
                </a:lnTo>
                <a:lnTo>
                  <a:pt x="2012" y="81"/>
                </a:lnTo>
                <a:lnTo>
                  <a:pt x="2067" y="78"/>
                </a:lnTo>
                <a:lnTo>
                  <a:pt x="2122" y="78"/>
                </a:lnTo>
                <a:lnTo>
                  <a:pt x="2176" y="71"/>
                </a:lnTo>
                <a:lnTo>
                  <a:pt x="2230" y="67"/>
                </a:lnTo>
                <a:lnTo>
                  <a:pt x="2284" y="60"/>
                </a:lnTo>
                <a:lnTo>
                  <a:pt x="2339" y="60"/>
                </a:lnTo>
                <a:lnTo>
                  <a:pt x="2394" y="54"/>
                </a:lnTo>
                <a:lnTo>
                  <a:pt x="2448" y="51"/>
                </a:lnTo>
                <a:lnTo>
                  <a:pt x="2502" y="44"/>
                </a:lnTo>
                <a:lnTo>
                  <a:pt x="2556" y="42"/>
                </a:lnTo>
                <a:lnTo>
                  <a:pt x="2611" y="33"/>
                </a:lnTo>
                <a:lnTo>
                  <a:pt x="2666" y="30"/>
                </a:lnTo>
                <a:lnTo>
                  <a:pt x="2720" y="27"/>
                </a:lnTo>
                <a:lnTo>
                  <a:pt x="2774" y="27"/>
                </a:lnTo>
                <a:lnTo>
                  <a:pt x="2828" y="27"/>
                </a:lnTo>
                <a:lnTo>
                  <a:pt x="2883" y="33"/>
                </a:lnTo>
                <a:lnTo>
                  <a:pt x="2938" y="33"/>
                </a:lnTo>
                <a:lnTo>
                  <a:pt x="2992" y="36"/>
                </a:lnTo>
                <a:lnTo>
                  <a:pt x="3046" y="33"/>
                </a:lnTo>
                <a:lnTo>
                  <a:pt x="3100" y="30"/>
                </a:lnTo>
                <a:lnTo>
                  <a:pt x="3155" y="33"/>
                </a:lnTo>
                <a:lnTo>
                  <a:pt x="3210" y="30"/>
                </a:lnTo>
                <a:lnTo>
                  <a:pt x="3264" y="23"/>
                </a:lnTo>
                <a:lnTo>
                  <a:pt x="3318" y="15"/>
                </a:lnTo>
                <a:lnTo>
                  <a:pt x="3372" y="11"/>
                </a:lnTo>
                <a:lnTo>
                  <a:pt x="3427" y="11"/>
                </a:lnTo>
                <a:lnTo>
                  <a:pt x="3482" y="11"/>
                </a:lnTo>
                <a:lnTo>
                  <a:pt x="3536" y="11"/>
                </a:lnTo>
                <a:lnTo>
                  <a:pt x="3590" y="9"/>
                </a:lnTo>
                <a:lnTo>
                  <a:pt x="3644" y="9"/>
                </a:lnTo>
                <a:lnTo>
                  <a:pt x="3699" y="9"/>
                </a:lnTo>
                <a:lnTo>
                  <a:pt x="3754" y="9"/>
                </a:lnTo>
                <a:lnTo>
                  <a:pt x="3808" y="5"/>
                </a:lnTo>
                <a:lnTo>
                  <a:pt x="3862" y="5"/>
                </a:lnTo>
                <a:lnTo>
                  <a:pt x="3916" y="5"/>
                </a:lnTo>
                <a:lnTo>
                  <a:pt x="3970" y="5"/>
                </a:lnTo>
                <a:lnTo>
                  <a:pt x="4026" y="5"/>
                </a:lnTo>
                <a:lnTo>
                  <a:pt x="4080" y="5"/>
                </a:lnTo>
                <a:lnTo>
                  <a:pt x="4134" y="5"/>
                </a:lnTo>
                <a:lnTo>
                  <a:pt x="4188" y="5"/>
                </a:lnTo>
                <a:lnTo>
                  <a:pt x="4242" y="5"/>
                </a:lnTo>
                <a:lnTo>
                  <a:pt x="4298" y="5"/>
                </a:lnTo>
                <a:lnTo>
                  <a:pt x="4352" y="5"/>
                </a:lnTo>
                <a:lnTo>
                  <a:pt x="4406" y="5"/>
                </a:lnTo>
                <a:lnTo>
                  <a:pt x="4460" y="9"/>
                </a:lnTo>
                <a:lnTo>
                  <a:pt x="4514" y="5"/>
                </a:lnTo>
                <a:lnTo>
                  <a:pt x="4570" y="5"/>
                </a:lnTo>
                <a:lnTo>
                  <a:pt x="4624" y="3"/>
                </a:lnTo>
                <a:lnTo>
                  <a:pt x="4678" y="3"/>
                </a:lnTo>
                <a:lnTo>
                  <a:pt x="4732" y="3"/>
                </a:lnTo>
                <a:lnTo>
                  <a:pt x="4786" y="3"/>
                </a:lnTo>
                <a:lnTo>
                  <a:pt x="4842" y="3"/>
                </a:lnTo>
                <a:lnTo>
                  <a:pt x="4896" y="3"/>
                </a:lnTo>
                <a:lnTo>
                  <a:pt x="4950" y="3"/>
                </a:lnTo>
                <a:lnTo>
                  <a:pt x="5004" y="0"/>
                </a:lnTo>
                <a:lnTo>
                  <a:pt x="5058" y="0"/>
                </a:lnTo>
                <a:lnTo>
                  <a:pt x="5114" y="3"/>
                </a:lnTo>
                <a:lnTo>
                  <a:pt x="5168" y="3"/>
                </a:lnTo>
                <a:lnTo>
                  <a:pt x="5222" y="3"/>
                </a:lnTo>
                <a:lnTo>
                  <a:pt x="5276" y="0"/>
                </a:lnTo>
                <a:lnTo>
                  <a:pt x="5330" y="0"/>
                </a:lnTo>
                <a:lnTo>
                  <a:pt x="5386" y="0"/>
                </a:lnTo>
              </a:path>
            </a:pathLst>
          </a:custGeom>
          <a:noFill/>
          <a:ln w="19080">
            <a:solidFill>
              <a:srgbClr val="00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1708200" y="577800"/>
            <a:ext cx="1797120" cy="611280"/>
          </a:xfrm>
          <a:custGeom>
            <a:avLst/>
            <a:gdLst/>
            <a:ahLst/>
            <a:rect l="l" t="t" r="r" b="b"/>
            <a:pathLst>
              <a:path w="5386" h="1834">
                <a:moveTo>
                  <a:pt x="0" y="1834"/>
                </a:moveTo>
                <a:lnTo>
                  <a:pt x="54" y="1719"/>
                </a:lnTo>
                <a:lnTo>
                  <a:pt x="109" y="1601"/>
                </a:lnTo>
                <a:lnTo>
                  <a:pt x="163" y="1474"/>
                </a:lnTo>
                <a:lnTo>
                  <a:pt x="218" y="1387"/>
                </a:lnTo>
                <a:lnTo>
                  <a:pt x="272" y="1306"/>
                </a:lnTo>
                <a:lnTo>
                  <a:pt x="326" y="1246"/>
                </a:lnTo>
                <a:lnTo>
                  <a:pt x="381" y="1188"/>
                </a:lnTo>
                <a:lnTo>
                  <a:pt x="435" y="1134"/>
                </a:lnTo>
                <a:lnTo>
                  <a:pt x="490" y="1084"/>
                </a:lnTo>
                <a:lnTo>
                  <a:pt x="544" y="1043"/>
                </a:lnTo>
                <a:lnTo>
                  <a:pt x="598" y="1003"/>
                </a:lnTo>
                <a:lnTo>
                  <a:pt x="652" y="958"/>
                </a:lnTo>
                <a:lnTo>
                  <a:pt x="707" y="897"/>
                </a:lnTo>
                <a:lnTo>
                  <a:pt x="762" y="843"/>
                </a:lnTo>
                <a:lnTo>
                  <a:pt x="816" y="798"/>
                </a:lnTo>
                <a:lnTo>
                  <a:pt x="870" y="783"/>
                </a:lnTo>
                <a:lnTo>
                  <a:pt x="924" y="771"/>
                </a:lnTo>
                <a:lnTo>
                  <a:pt x="979" y="762"/>
                </a:lnTo>
                <a:lnTo>
                  <a:pt x="1034" y="731"/>
                </a:lnTo>
                <a:lnTo>
                  <a:pt x="1088" y="702"/>
                </a:lnTo>
                <a:lnTo>
                  <a:pt x="1142" y="662"/>
                </a:lnTo>
                <a:lnTo>
                  <a:pt x="1196" y="632"/>
                </a:lnTo>
                <a:lnTo>
                  <a:pt x="1251" y="605"/>
                </a:lnTo>
                <a:lnTo>
                  <a:pt x="1306" y="577"/>
                </a:lnTo>
                <a:lnTo>
                  <a:pt x="1360" y="557"/>
                </a:lnTo>
                <a:lnTo>
                  <a:pt x="1414" y="529"/>
                </a:lnTo>
                <a:lnTo>
                  <a:pt x="1468" y="501"/>
                </a:lnTo>
                <a:lnTo>
                  <a:pt x="1523" y="468"/>
                </a:lnTo>
                <a:lnTo>
                  <a:pt x="1578" y="441"/>
                </a:lnTo>
                <a:lnTo>
                  <a:pt x="1632" y="420"/>
                </a:lnTo>
                <a:lnTo>
                  <a:pt x="1686" y="411"/>
                </a:lnTo>
                <a:lnTo>
                  <a:pt x="1740" y="401"/>
                </a:lnTo>
                <a:lnTo>
                  <a:pt x="1795" y="397"/>
                </a:lnTo>
                <a:lnTo>
                  <a:pt x="1850" y="374"/>
                </a:lnTo>
                <a:lnTo>
                  <a:pt x="1904" y="357"/>
                </a:lnTo>
                <a:lnTo>
                  <a:pt x="1958" y="335"/>
                </a:lnTo>
                <a:lnTo>
                  <a:pt x="2012" y="330"/>
                </a:lnTo>
                <a:lnTo>
                  <a:pt x="2067" y="314"/>
                </a:lnTo>
                <a:lnTo>
                  <a:pt x="2122" y="308"/>
                </a:lnTo>
                <a:lnTo>
                  <a:pt x="2176" y="296"/>
                </a:lnTo>
                <a:lnTo>
                  <a:pt x="2230" y="291"/>
                </a:lnTo>
                <a:lnTo>
                  <a:pt x="2284" y="281"/>
                </a:lnTo>
                <a:lnTo>
                  <a:pt x="2339" y="272"/>
                </a:lnTo>
                <a:lnTo>
                  <a:pt x="2394" y="262"/>
                </a:lnTo>
                <a:lnTo>
                  <a:pt x="2448" y="262"/>
                </a:lnTo>
                <a:lnTo>
                  <a:pt x="2502" y="262"/>
                </a:lnTo>
                <a:lnTo>
                  <a:pt x="2556" y="248"/>
                </a:lnTo>
                <a:lnTo>
                  <a:pt x="2611" y="233"/>
                </a:lnTo>
                <a:lnTo>
                  <a:pt x="2666" y="208"/>
                </a:lnTo>
                <a:lnTo>
                  <a:pt x="2720" y="200"/>
                </a:lnTo>
                <a:lnTo>
                  <a:pt x="2774" y="191"/>
                </a:lnTo>
                <a:lnTo>
                  <a:pt x="2828" y="191"/>
                </a:lnTo>
                <a:lnTo>
                  <a:pt x="2883" y="181"/>
                </a:lnTo>
                <a:lnTo>
                  <a:pt x="2938" y="179"/>
                </a:lnTo>
                <a:lnTo>
                  <a:pt x="2992" y="179"/>
                </a:lnTo>
                <a:lnTo>
                  <a:pt x="3046" y="185"/>
                </a:lnTo>
                <a:lnTo>
                  <a:pt x="3100" y="181"/>
                </a:lnTo>
                <a:lnTo>
                  <a:pt x="3155" y="163"/>
                </a:lnTo>
                <a:lnTo>
                  <a:pt x="3210" y="146"/>
                </a:lnTo>
                <a:lnTo>
                  <a:pt x="3264" y="133"/>
                </a:lnTo>
                <a:lnTo>
                  <a:pt x="3318" y="125"/>
                </a:lnTo>
                <a:lnTo>
                  <a:pt x="3372" y="118"/>
                </a:lnTo>
                <a:lnTo>
                  <a:pt x="3427" y="109"/>
                </a:lnTo>
                <a:lnTo>
                  <a:pt x="3482" y="102"/>
                </a:lnTo>
                <a:lnTo>
                  <a:pt x="3536" y="100"/>
                </a:lnTo>
                <a:lnTo>
                  <a:pt x="3590" y="102"/>
                </a:lnTo>
                <a:lnTo>
                  <a:pt x="3644" y="112"/>
                </a:lnTo>
                <a:lnTo>
                  <a:pt x="3699" y="121"/>
                </a:lnTo>
                <a:lnTo>
                  <a:pt x="3754" y="118"/>
                </a:lnTo>
                <a:lnTo>
                  <a:pt x="3808" y="102"/>
                </a:lnTo>
                <a:lnTo>
                  <a:pt x="3862" y="88"/>
                </a:lnTo>
                <a:lnTo>
                  <a:pt x="3916" y="75"/>
                </a:lnTo>
                <a:lnTo>
                  <a:pt x="3970" y="73"/>
                </a:lnTo>
                <a:lnTo>
                  <a:pt x="4026" y="69"/>
                </a:lnTo>
                <a:lnTo>
                  <a:pt x="4080" y="67"/>
                </a:lnTo>
                <a:lnTo>
                  <a:pt x="4134" y="58"/>
                </a:lnTo>
                <a:lnTo>
                  <a:pt x="4188" y="58"/>
                </a:lnTo>
                <a:lnTo>
                  <a:pt x="4242" y="58"/>
                </a:lnTo>
                <a:lnTo>
                  <a:pt x="4298" y="61"/>
                </a:lnTo>
                <a:lnTo>
                  <a:pt x="4352" y="63"/>
                </a:lnTo>
                <a:lnTo>
                  <a:pt x="4406" y="63"/>
                </a:lnTo>
                <a:lnTo>
                  <a:pt x="4460" y="52"/>
                </a:lnTo>
                <a:lnTo>
                  <a:pt x="4514" y="36"/>
                </a:lnTo>
                <a:lnTo>
                  <a:pt x="4570" y="27"/>
                </a:lnTo>
                <a:lnTo>
                  <a:pt x="4624" y="30"/>
                </a:lnTo>
                <a:lnTo>
                  <a:pt x="4678" y="34"/>
                </a:lnTo>
                <a:lnTo>
                  <a:pt x="4732" y="36"/>
                </a:lnTo>
                <a:lnTo>
                  <a:pt x="4786" y="36"/>
                </a:lnTo>
                <a:lnTo>
                  <a:pt x="4842" y="34"/>
                </a:lnTo>
                <a:lnTo>
                  <a:pt x="4896" y="34"/>
                </a:lnTo>
                <a:lnTo>
                  <a:pt x="4950" y="27"/>
                </a:lnTo>
                <a:lnTo>
                  <a:pt x="5004" y="21"/>
                </a:lnTo>
                <a:lnTo>
                  <a:pt x="5058" y="15"/>
                </a:lnTo>
                <a:lnTo>
                  <a:pt x="5114" y="19"/>
                </a:lnTo>
                <a:lnTo>
                  <a:pt x="5168" y="25"/>
                </a:lnTo>
                <a:lnTo>
                  <a:pt x="5222" y="25"/>
                </a:lnTo>
                <a:lnTo>
                  <a:pt x="5276" y="15"/>
                </a:lnTo>
                <a:lnTo>
                  <a:pt x="5330" y="3"/>
                </a:lnTo>
                <a:lnTo>
                  <a:pt x="5386" y="0"/>
                </a:lnTo>
              </a:path>
            </a:pathLst>
          </a:custGeom>
          <a:noFill/>
          <a:ln w="19080">
            <a:solidFill>
              <a:srgbClr val="96969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1708200" y="1069920"/>
            <a:ext cx="1797120" cy="208080"/>
          </a:xfrm>
          <a:custGeom>
            <a:avLst/>
            <a:gdLst/>
            <a:ahLst/>
            <a:rect l="l" t="t" r="r" b="b"/>
            <a:pathLst>
              <a:path w="5386" h="626">
                <a:moveTo>
                  <a:pt x="0" y="626"/>
                </a:moveTo>
                <a:lnTo>
                  <a:pt x="54" y="590"/>
                </a:lnTo>
                <a:lnTo>
                  <a:pt x="109" y="559"/>
                </a:lnTo>
                <a:lnTo>
                  <a:pt x="163" y="542"/>
                </a:lnTo>
                <a:lnTo>
                  <a:pt x="218" y="515"/>
                </a:lnTo>
                <a:lnTo>
                  <a:pt x="272" y="493"/>
                </a:lnTo>
                <a:lnTo>
                  <a:pt x="326" y="459"/>
                </a:lnTo>
                <a:lnTo>
                  <a:pt x="381" y="442"/>
                </a:lnTo>
                <a:lnTo>
                  <a:pt x="435" y="415"/>
                </a:lnTo>
                <a:lnTo>
                  <a:pt x="490" y="403"/>
                </a:lnTo>
                <a:lnTo>
                  <a:pt x="544" y="393"/>
                </a:lnTo>
                <a:lnTo>
                  <a:pt x="598" y="384"/>
                </a:lnTo>
                <a:lnTo>
                  <a:pt x="652" y="370"/>
                </a:lnTo>
                <a:lnTo>
                  <a:pt x="707" y="351"/>
                </a:lnTo>
                <a:lnTo>
                  <a:pt x="762" y="336"/>
                </a:lnTo>
                <a:lnTo>
                  <a:pt x="816" y="320"/>
                </a:lnTo>
                <a:lnTo>
                  <a:pt x="870" y="312"/>
                </a:lnTo>
                <a:lnTo>
                  <a:pt x="924" y="306"/>
                </a:lnTo>
                <a:lnTo>
                  <a:pt x="979" y="293"/>
                </a:lnTo>
                <a:lnTo>
                  <a:pt x="1034" y="285"/>
                </a:lnTo>
                <a:lnTo>
                  <a:pt x="1088" y="270"/>
                </a:lnTo>
                <a:lnTo>
                  <a:pt x="1142" y="272"/>
                </a:lnTo>
                <a:lnTo>
                  <a:pt x="1196" y="266"/>
                </a:lnTo>
                <a:lnTo>
                  <a:pt x="1251" y="266"/>
                </a:lnTo>
                <a:lnTo>
                  <a:pt x="1306" y="254"/>
                </a:lnTo>
                <a:lnTo>
                  <a:pt x="1360" y="252"/>
                </a:lnTo>
                <a:lnTo>
                  <a:pt x="1414" y="243"/>
                </a:lnTo>
                <a:lnTo>
                  <a:pt x="1468" y="245"/>
                </a:lnTo>
                <a:lnTo>
                  <a:pt x="1523" y="243"/>
                </a:lnTo>
                <a:lnTo>
                  <a:pt x="1578" y="243"/>
                </a:lnTo>
                <a:lnTo>
                  <a:pt x="1632" y="237"/>
                </a:lnTo>
                <a:lnTo>
                  <a:pt x="1686" y="239"/>
                </a:lnTo>
                <a:lnTo>
                  <a:pt x="1740" y="237"/>
                </a:lnTo>
                <a:lnTo>
                  <a:pt x="1795" y="233"/>
                </a:lnTo>
                <a:lnTo>
                  <a:pt x="1850" y="212"/>
                </a:lnTo>
                <a:lnTo>
                  <a:pt x="1904" y="188"/>
                </a:lnTo>
                <a:lnTo>
                  <a:pt x="1958" y="167"/>
                </a:lnTo>
                <a:lnTo>
                  <a:pt x="2012" y="173"/>
                </a:lnTo>
                <a:lnTo>
                  <a:pt x="2067" y="181"/>
                </a:lnTo>
                <a:lnTo>
                  <a:pt x="2122" y="188"/>
                </a:lnTo>
                <a:lnTo>
                  <a:pt x="2176" y="176"/>
                </a:lnTo>
                <a:lnTo>
                  <a:pt x="2230" y="160"/>
                </a:lnTo>
                <a:lnTo>
                  <a:pt x="2284" y="158"/>
                </a:lnTo>
                <a:lnTo>
                  <a:pt x="2339" y="158"/>
                </a:lnTo>
                <a:lnTo>
                  <a:pt x="2394" y="167"/>
                </a:lnTo>
                <a:lnTo>
                  <a:pt x="2448" y="158"/>
                </a:lnTo>
                <a:lnTo>
                  <a:pt x="2502" y="158"/>
                </a:lnTo>
                <a:lnTo>
                  <a:pt x="2556" y="154"/>
                </a:lnTo>
                <a:lnTo>
                  <a:pt x="2611" y="170"/>
                </a:lnTo>
                <a:lnTo>
                  <a:pt x="2666" y="176"/>
                </a:lnTo>
                <a:lnTo>
                  <a:pt x="2720" y="188"/>
                </a:lnTo>
                <a:lnTo>
                  <a:pt x="2774" y="179"/>
                </a:lnTo>
                <a:lnTo>
                  <a:pt x="2828" y="170"/>
                </a:lnTo>
                <a:lnTo>
                  <a:pt x="2883" y="148"/>
                </a:lnTo>
                <a:lnTo>
                  <a:pt x="2938" y="140"/>
                </a:lnTo>
                <a:lnTo>
                  <a:pt x="2992" y="133"/>
                </a:lnTo>
                <a:lnTo>
                  <a:pt x="3046" y="137"/>
                </a:lnTo>
                <a:lnTo>
                  <a:pt x="3100" y="137"/>
                </a:lnTo>
                <a:lnTo>
                  <a:pt x="3155" y="146"/>
                </a:lnTo>
                <a:lnTo>
                  <a:pt x="3210" y="152"/>
                </a:lnTo>
                <a:lnTo>
                  <a:pt x="3264" y="143"/>
                </a:lnTo>
                <a:lnTo>
                  <a:pt x="3318" y="115"/>
                </a:lnTo>
                <a:lnTo>
                  <a:pt x="3372" y="82"/>
                </a:lnTo>
                <a:lnTo>
                  <a:pt x="3427" y="64"/>
                </a:lnTo>
                <a:lnTo>
                  <a:pt x="3482" y="77"/>
                </a:lnTo>
                <a:lnTo>
                  <a:pt x="3536" y="100"/>
                </a:lnTo>
                <a:lnTo>
                  <a:pt x="3590" y="125"/>
                </a:lnTo>
                <a:lnTo>
                  <a:pt x="3644" y="121"/>
                </a:lnTo>
                <a:lnTo>
                  <a:pt x="3699" y="100"/>
                </a:lnTo>
                <a:lnTo>
                  <a:pt x="3754" y="82"/>
                </a:lnTo>
                <a:lnTo>
                  <a:pt x="3808" y="82"/>
                </a:lnTo>
                <a:lnTo>
                  <a:pt x="3862" y="98"/>
                </a:lnTo>
                <a:lnTo>
                  <a:pt x="3916" y="110"/>
                </a:lnTo>
                <a:lnTo>
                  <a:pt x="3970" y="104"/>
                </a:lnTo>
                <a:lnTo>
                  <a:pt x="4026" y="98"/>
                </a:lnTo>
                <a:lnTo>
                  <a:pt x="4080" y="92"/>
                </a:lnTo>
                <a:lnTo>
                  <a:pt x="4134" y="104"/>
                </a:lnTo>
                <a:lnTo>
                  <a:pt x="4188" y="110"/>
                </a:lnTo>
                <a:lnTo>
                  <a:pt x="4242" y="104"/>
                </a:lnTo>
                <a:lnTo>
                  <a:pt x="4298" y="82"/>
                </a:lnTo>
                <a:lnTo>
                  <a:pt x="4352" y="71"/>
                </a:lnTo>
                <a:lnTo>
                  <a:pt x="4406" y="55"/>
                </a:lnTo>
                <a:lnTo>
                  <a:pt x="4460" y="37"/>
                </a:lnTo>
                <a:lnTo>
                  <a:pt x="4514" y="19"/>
                </a:lnTo>
                <a:lnTo>
                  <a:pt x="4570" y="21"/>
                </a:lnTo>
                <a:lnTo>
                  <a:pt x="4624" y="34"/>
                </a:lnTo>
                <a:lnTo>
                  <a:pt x="4678" y="48"/>
                </a:lnTo>
                <a:lnTo>
                  <a:pt x="4732" y="40"/>
                </a:lnTo>
                <a:lnTo>
                  <a:pt x="4786" y="28"/>
                </a:lnTo>
                <a:lnTo>
                  <a:pt x="4842" y="10"/>
                </a:lnTo>
                <a:lnTo>
                  <a:pt x="4896" y="4"/>
                </a:lnTo>
                <a:lnTo>
                  <a:pt x="4950" y="15"/>
                </a:lnTo>
                <a:lnTo>
                  <a:pt x="5004" y="34"/>
                </a:lnTo>
                <a:lnTo>
                  <a:pt x="5058" y="55"/>
                </a:lnTo>
                <a:lnTo>
                  <a:pt x="5114" y="46"/>
                </a:lnTo>
                <a:lnTo>
                  <a:pt x="5168" y="34"/>
                </a:lnTo>
                <a:lnTo>
                  <a:pt x="5222" y="28"/>
                </a:lnTo>
                <a:lnTo>
                  <a:pt x="5276" y="25"/>
                </a:lnTo>
                <a:lnTo>
                  <a:pt x="5330" y="15"/>
                </a:lnTo>
                <a:lnTo>
                  <a:pt x="5386" y="0"/>
                </a:lnTo>
              </a:path>
            </a:pathLst>
          </a:custGeom>
          <a:noFill/>
          <a:ln w="19080">
            <a:solidFill>
              <a:srgbClr val="ff33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1708200" y="5213520"/>
            <a:ext cx="1797120" cy="560160"/>
          </a:xfrm>
          <a:custGeom>
            <a:avLst/>
            <a:gdLst/>
            <a:ahLst/>
            <a:rect l="l" t="t" r="r" b="b"/>
            <a:pathLst>
              <a:path w="5386" h="1680">
                <a:moveTo>
                  <a:pt x="0" y="1680"/>
                </a:moveTo>
                <a:lnTo>
                  <a:pt x="54" y="1607"/>
                </a:lnTo>
                <a:lnTo>
                  <a:pt x="109" y="1532"/>
                </a:lnTo>
                <a:lnTo>
                  <a:pt x="163" y="1469"/>
                </a:lnTo>
                <a:lnTo>
                  <a:pt x="218" y="1414"/>
                </a:lnTo>
                <a:lnTo>
                  <a:pt x="272" y="1360"/>
                </a:lnTo>
                <a:lnTo>
                  <a:pt x="326" y="1306"/>
                </a:lnTo>
                <a:lnTo>
                  <a:pt x="381" y="1264"/>
                </a:lnTo>
                <a:lnTo>
                  <a:pt x="435" y="1242"/>
                </a:lnTo>
                <a:lnTo>
                  <a:pt x="490" y="1212"/>
                </a:lnTo>
                <a:lnTo>
                  <a:pt x="544" y="1175"/>
                </a:lnTo>
                <a:lnTo>
                  <a:pt x="598" y="1121"/>
                </a:lnTo>
                <a:lnTo>
                  <a:pt x="652" y="1069"/>
                </a:lnTo>
                <a:lnTo>
                  <a:pt x="707" y="1030"/>
                </a:lnTo>
                <a:lnTo>
                  <a:pt x="762" y="992"/>
                </a:lnTo>
                <a:lnTo>
                  <a:pt x="816" y="955"/>
                </a:lnTo>
                <a:lnTo>
                  <a:pt x="870" y="909"/>
                </a:lnTo>
                <a:lnTo>
                  <a:pt x="924" y="861"/>
                </a:lnTo>
                <a:lnTo>
                  <a:pt x="979" y="822"/>
                </a:lnTo>
                <a:lnTo>
                  <a:pt x="1034" y="791"/>
                </a:lnTo>
                <a:lnTo>
                  <a:pt x="1088" y="764"/>
                </a:lnTo>
                <a:lnTo>
                  <a:pt x="1142" y="741"/>
                </a:lnTo>
                <a:lnTo>
                  <a:pt x="1196" y="714"/>
                </a:lnTo>
                <a:lnTo>
                  <a:pt x="1251" y="701"/>
                </a:lnTo>
                <a:lnTo>
                  <a:pt x="1306" y="695"/>
                </a:lnTo>
                <a:lnTo>
                  <a:pt x="1360" y="692"/>
                </a:lnTo>
                <a:lnTo>
                  <a:pt x="1414" y="677"/>
                </a:lnTo>
                <a:lnTo>
                  <a:pt x="1468" y="662"/>
                </a:lnTo>
                <a:lnTo>
                  <a:pt x="1523" y="641"/>
                </a:lnTo>
                <a:lnTo>
                  <a:pt x="1578" y="620"/>
                </a:lnTo>
                <a:lnTo>
                  <a:pt x="1632" y="592"/>
                </a:lnTo>
                <a:lnTo>
                  <a:pt x="1686" y="581"/>
                </a:lnTo>
                <a:lnTo>
                  <a:pt x="1740" y="571"/>
                </a:lnTo>
                <a:lnTo>
                  <a:pt x="1795" y="565"/>
                </a:lnTo>
                <a:lnTo>
                  <a:pt x="1850" y="544"/>
                </a:lnTo>
                <a:lnTo>
                  <a:pt x="1904" y="523"/>
                </a:lnTo>
                <a:lnTo>
                  <a:pt x="1958" y="492"/>
                </a:lnTo>
                <a:lnTo>
                  <a:pt x="2012" y="471"/>
                </a:lnTo>
                <a:lnTo>
                  <a:pt x="2067" y="448"/>
                </a:lnTo>
                <a:lnTo>
                  <a:pt x="2122" y="436"/>
                </a:lnTo>
                <a:lnTo>
                  <a:pt x="2176" y="423"/>
                </a:lnTo>
                <a:lnTo>
                  <a:pt x="2230" y="417"/>
                </a:lnTo>
                <a:lnTo>
                  <a:pt x="2284" y="415"/>
                </a:lnTo>
                <a:lnTo>
                  <a:pt x="2339" y="417"/>
                </a:lnTo>
                <a:lnTo>
                  <a:pt x="2394" y="417"/>
                </a:lnTo>
                <a:lnTo>
                  <a:pt x="2448" y="411"/>
                </a:lnTo>
                <a:lnTo>
                  <a:pt x="2502" y="402"/>
                </a:lnTo>
                <a:lnTo>
                  <a:pt x="2556" y="399"/>
                </a:lnTo>
                <a:lnTo>
                  <a:pt x="2611" y="393"/>
                </a:lnTo>
                <a:lnTo>
                  <a:pt x="2666" y="378"/>
                </a:lnTo>
                <a:lnTo>
                  <a:pt x="2720" y="345"/>
                </a:lnTo>
                <a:lnTo>
                  <a:pt x="2774" y="330"/>
                </a:lnTo>
                <a:lnTo>
                  <a:pt x="2828" y="320"/>
                </a:lnTo>
                <a:lnTo>
                  <a:pt x="2883" y="326"/>
                </a:lnTo>
                <a:lnTo>
                  <a:pt x="2938" y="317"/>
                </a:lnTo>
                <a:lnTo>
                  <a:pt x="2992" y="303"/>
                </a:lnTo>
                <a:lnTo>
                  <a:pt x="3046" y="284"/>
                </a:lnTo>
                <a:lnTo>
                  <a:pt x="3100" y="269"/>
                </a:lnTo>
                <a:lnTo>
                  <a:pt x="3155" y="257"/>
                </a:lnTo>
                <a:lnTo>
                  <a:pt x="3210" y="247"/>
                </a:lnTo>
                <a:lnTo>
                  <a:pt x="3264" y="242"/>
                </a:lnTo>
                <a:lnTo>
                  <a:pt x="3318" y="253"/>
                </a:lnTo>
                <a:lnTo>
                  <a:pt x="3372" y="257"/>
                </a:lnTo>
                <a:lnTo>
                  <a:pt x="3427" y="253"/>
                </a:lnTo>
                <a:lnTo>
                  <a:pt x="3482" y="226"/>
                </a:lnTo>
                <a:lnTo>
                  <a:pt x="3536" y="214"/>
                </a:lnTo>
                <a:lnTo>
                  <a:pt x="3590" y="197"/>
                </a:lnTo>
                <a:lnTo>
                  <a:pt x="3644" y="205"/>
                </a:lnTo>
                <a:lnTo>
                  <a:pt x="3699" y="191"/>
                </a:lnTo>
                <a:lnTo>
                  <a:pt x="3754" y="178"/>
                </a:lnTo>
                <a:lnTo>
                  <a:pt x="3808" y="148"/>
                </a:lnTo>
                <a:lnTo>
                  <a:pt x="3862" y="127"/>
                </a:lnTo>
                <a:lnTo>
                  <a:pt x="3916" y="114"/>
                </a:lnTo>
                <a:lnTo>
                  <a:pt x="3970" y="112"/>
                </a:lnTo>
                <a:lnTo>
                  <a:pt x="4026" y="114"/>
                </a:lnTo>
                <a:lnTo>
                  <a:pt x="4080" y="118"/>
                </a:lnTo>
                <a:lnTo>
                  <a:pt x="4134" y="130"/>
                </a:lnTo>
                <a:lnTo>
                  <a:pt x="4188" y="133"/>
                </a:lnTo>
                <a:lnTo>
                  <a:pt x="4242" y="139"/>
                </a:lnTo>
                <a:lnTo>
                  <a:pt x="4298" y="130"/>
                </a:lnTo>
                <a:lnTo>
                  <a:pt x="4352" y="118"/>
                </a:lnTo>
                <a:lnTo>
                  <a:pt x="4406" y="103"/>
                </a:lnTo>
                <a:lnTo>
                  <a:pt x="4460" y="100"/>
                </a:lnTo>
                <a:lnTo>
                  <a:pt x="4514" y="87"/>
                </a:lnTo>
                <a:lnTo>
                  <a:pt x="4570" y="76"/>
                </a:lnTo>
                <a:lnTo>
                  <a:pt x="4624" y="60"/>
                </a:lnTo>
                <a:lnTo>
                  <a:pt x="4678" y="60"/>
                </a:lnTo>
                <a:lnTo>
                  <a:pt x="4732" y="60"/>
                </a:lnTo>
                <a:lnTo>
                  <a:pt x="4786" y="54"/>
                </a:lnTo>
                <a:lnTo>
                  <a:pt x="4842" y="43"/>
                </a:lnTo>
                <a:lnTo>
                  <a:pt x="4896" y="37"/>
                </a:lnTo>
                <a:lnTo>
                  <a:pt x="4950" y="33"/>
                </a:lnTo>
                <a:lnTo>
                  <a:pt x="5004" y="31"/>
                </a:lnTo>
                <a:lnTo>
                  <a:pt x="5058" y="25"/>
                </a:lnTo>
                <a:lnTo>
                  <a:pt x="5114" y="27"/>
                </a:lnTo>
                <a:lnTo>
                  <a:pt x="5168" y="27"/>
                </a:lnTo>
                <a:lnTo>
                  <a:pt x="5222" y="21"/>
                </a:lnTo>
                <a:lnTo>
                  <a:pt x="5276" y="12"/>
                </a:lnTo>
                <a:lnTo>
                  <a:pt x="5330" y="6"/>
                </a:lnTo>
                <a:lnTo>
                  <a:pt x="5386" y="0"/>
                </a:lnTo>
              </a:path>
            </a:pathLst>
          </a:custGeom>
          <a:noFill/>
          <a:ln w="19080">
            <a:solidFill>
              <a:srgbClr val="ff33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708200" y="5114880"/>
            <a:ext cx="1797120" cy="617760"/>
          </a:xfrm>
          <a:custGeom>
            <a:avLst/>
            <a:gdLst/>
            <a:ahLst/>
            <a:rect l="l" t="t" r="r" b="b"/>
            <a:pathLst>
              <a:path w="5386" h="1852">
                <a:moveTo>
                  <a:pt x="0" y="1852"/>
                </a:moveTo>
                <a:lnTo>
                  <a:pt x="54" y="1746"/>
                </a:lnTo>
                <a:lnTo>
                  <a:pt x="109" y="1625"/>
                </a:lnTo>
                <a:lnTo>
                  <a:pt x="163" y="1510"/>
                </a:lnTo>
                <a:lnTo>
                  <a:pt x="218" y="1416"/>
                </a:lnTo>
                <a:lnTo>
                  <a:pt x="272" y="1341"/>
                </a:lnTo>
                <a:lnTo>
                  <a:pt x="326" y="1275"/>
                </a:lnTo>
                <a:lnTo>
                  <a:pt x="381" y="1202"/>
                </a:lnTo>
                <a:lnTo>
                  <a:pt x="435" y="1135"/>
                </a:lnTo>
                <a:lnTo>
                  <a:pt x="490" y="1071"/>
                </a:lnTo>
                <a:lnTo>
                  <a:pt x="544" y="1030"/>
                </a:lnTo>
                <a:lnTo>
                  <a:pt x="598" y="982"/>
                </a:lnTo>
                <a:lnTo>
                  <a:pt x="652" y="951"/>
                </a:lnTo>
                <a:lnTo>
                  <a:pt x="707" y="909"/>
                </a:lnTo>
                <a:lnTo>
                  <a:pt x="762" y="882"/>
                </a:lnTo>
                <a:lnTo>
                  <a:pt x="816" y="836"/>
                </a:lnTo>
                <a:lnTo>
                  <a:pt x="870" y="797"/>
                </a:lnTo>
                <a:lnTo>
                  <a:pt x="924" y="758"/>
                </a:lnTo>
                <a:lnTo>
                  <a:pt x="979" y="731"/>
                </a:lnTo>
                <a:lnTo>
                  <a:pt x="1034" y="706"/>
                </a:lnTo>
                <a:lnTo>
                  <a:pt x="1088" y="681"/>
                </a:lnTo>
                <a:lnTo>
                  <a:pt x="1142" y="664"/>
                </a:lnTo>
                <a:lnTo>
                  <a:pt x="1196" y="625"/>
                </a:lnTo>
                <a:lnTo>
                  <a:pt x="1251" y="582"/>
                </a:lnTo>
                <a:lnTo>
                  <a:pt x="1306" y="542"/>
                </a:lnTo>
                <a:lnTo>
                  <a:pt x="1360" y="525"/>
                </a:lnTo>
                <a:lnTo>
                  <a:pt x="1414" y="525"/>
                </a:lnTo>
                <a:lnTo>
                  <a:pt x="1468" y="513"/>
                </a:lnTo>
                <a:lnTo>
                  <a:pt x="1523" y="498"/>
                </a:lnTo>
                <a:lnTo>
                  <a:pt x="1578" y="467"/>
                </a:lnTo>
                <a:lnTo>
                  <a:pt x="1632" y="446"/>
                </a:lnTo>
                <a:lnTo>
                  <a:pt x="1686" y="428"/>
                </a:lnTo>
                <a:lnTo>
                  <a:pt x="1740" y="407"/>
                </a:lnTo>
                <a:lnTo>
                  <a:pt x="1795" y="382"/>
                </a:lnTo>
                <a:lnTo>
                  <a:pt x="1850" y="361"/>
                </a:lnTo>
                <a:lnTo>
                  <a:pt x="1904" y="355"/>
                </a:lnTo>
                <a:lnTo>
                  <a:pt x="1958" y="349"/>
                </a:lnTo>
                <a:lnTo>
                  <a:pt x="2012" y="338"/>
                </a:lnTo>
                <a:lnTo>
                  <a:pt x="2067" y="316"/>
                </a:lnTo>
                <a:lnTo>
                  <a:pt x="2122" y="301"/>
                </a:lnTo>
                <a:lnTo>
                  <a:pt x="2176" y="289"/>
                </a:lnTo>
                <a:lnTo>
                  <a:pt x="2230" y="280"/>
                </a:lnTo>
                <a:lnTo>
                  <a:pt x="2284" y="277"/>
                </a:lnTo>
                <a:lnTo>
                  <a:pt x="2339" y="274"/>
                </a:lnTo>
                <a:lnTo>
                  <a:pt x="2394" y="268"/>
                </a:lnTo>
                <a:lnTo>
                  <a:pt x="2448" y="253"/>
                </a:lnTo>
                <a:lnTo>
                  <a:pt x="2502" y="237"/>
                </a:lnTo>
                <a:lnTo>
                  <a:pt x="2556" y="226"/>
                </a:lnTo>
                <a:lnTo>
                  <a:pt x="2611" y="220"/>
                </a:lnTo>
                <a:lnTo>
                  <a:pt x="2666" y="216"/>
                </a:lnTo>
                <a:lnTo>
                  <a:pt x="2720" y="208"/>
                </a:lnTo>
                <a:lnTo>
                  <a:pt x="2774" y="193"/>
                </a:lnTo>
                <a:lnTo>
                  <a:pt x="2828" y="174"/>
                </a:lnTo>
                <a:lnTo>
                  <a:pt x="2883" y="166"/>
                </a:lnTo>
                <a:lnTo>
                  <a:pt x="2938" y="160"/>
                </a:lnTo>
                <a:lnTo>
                  <a:pt x="2992" y="153"/>
                </a:lnTo>
                <a:lnTo>
                  <a:pt x="3046" y="147"/>
                </a:lnTo>
                <a:lnTo>
                  <a:pt x="3100" y="147"/>
                </a:lnTo>
                <a:lnTo>
                  <a:pt x="3155" y="147"/>
                </a:lnTo>
                <a:lnTo>
                  <a:pt x="3210" y="144"/>
                </a:lnTo>
                <a:lnTo>
                  <a:pt x="3264" y="135"/>
                </a:lnTo>
                <a:lnTo>
                  <a:pt x="3318" y="133"/>
                </a:lnTo>
                <a:lnTo>
                  <a:pt x="3372" y="123"/>
                </a:lnTo>
                <a:lnTo>
                  <a:pt x="3427" y="110"/>
                </a:lnTo>
                <a:lnTo>
                  <a:pt x="3482" y="102"/>
                </a:lnTo>
                <a:lnTo>
                  <a:pt x="3536" y="96"/>
                </a:lnTo>
                <a:lnTo>
                  <a:pt x="3590" y="96"/>
                </a:lnTo>
                <a:lnTo>
                  <a:pt x="3644" y="89"/>
                </a:lnTo>
                <a:lnTo>
                  <a:pt x="3699" y="81"/>
                </a:lnTo>
                <a:lnTo>
                  <a:pt x="3754" y="71"/>
                </a:lnTo>
                <a:lnTo>
                  <a:pt x="3808" y="69"/>
                </a:lnTo>
                <a:lnTo>
                  <a:pt x="3862" y="71"/>
                </a:lnTo>
                <a:lnTo>
                  <a:pt x="3916" y="62"/>
                </a:lnTo>
                <a:lnTo>
                  <a:pt x="3970" y="66"/>
                </a:lnTo>
                <a:lnTo>
                  <a:pt x="4026" y="66"/>
                </a:lnTo>
                <a:lnTo>
                  <a:pt x="4080" y="75"/>
                </a:lnTo>
                <a:lnTo>
                  <a:pt x="4134" y="71"/>
                </a:lnTo>
                <a:lnTo>
                  <a:pt x="4188" y="66"/>
                </a:lnTo>
                <a:lnTo>
                  <a:pt x="4242" y="62"/>
                </a:lnTo>
                <a:lnTo>
                  <a:pt x="4298" y="54"/>
                </a:lnTo>
                <a:lnTo>
                  <a:pt x="4352" y="50"/>
                </a:lnTo>
                <a:lnTo>
                  <a:pt x="4406" y="44"/>
                </a:lnTo>
                <a:lnTo>
                  <a:pt x="4460" y="42"/>
                </a:lnTo>
                <a:lnTo>
                  <a:pt x="4514" y="38"/>
                </a:lnTo>
                <a:lnTo>
                  <a:pt x="4570" y="35"/>
                </a:lnTo>
                <a:lnTo>
                  <a:pt x="4624" y="33"/>
                </a:lnTo>
                <a:lnTo>
                  <a:pt x="4678" y="27"/>
                </a:lnTo>
                <a:lnTo>
                  <a:pt x="4732" y="17"/>
                </a:lnTo>
                <a:lnTo>
                  <a:pt x="4786" y="17"/>
                </a:lnTo>
                <a:lnTo>
                  <a:pt x="4842" y="17"/>
                </a:lnTo>
                <a:lnTo>
                  <a:pt x="4896" y="21"/>
                </a:lnTo>
                <a:lnTo>
                  <a:pt x="4950" y="17"/>
                </a:lnTo>
                <a:lnTo>
                  <a:pt x="5004" y="14"/>
                </a:lnTo>
                <a:lnTo>
                  <a:pt x="5058" y="14"/>
                </a:lnTo>
                <a:lnTo>
                  <a:pt x="5114" y="17"/>
                </a:lnTo>
                <a:lnTo>
                  <a:pt x="5168" y="21"/>
                </a:lnTo>
                <a:lnTo>
                  <a:pt x="5222" y="17"/>
                </a:lnTo>
                <a:lnTo>
                  <a:pt x="5276" y="8"/>
                </a:lnTo>
                <a:lnTo>
                  <a:pt x="5330" y="0"/>
                </a:lnTo>
                <a:lnTo>
                  <a:pt x="5386" y="0"/>
                </a:lnTo>
              </a:path>
            </a:pathLst>
          </a:custGeom>
          <a:noFill/>
          <a:ln w="19080">
            <a:solidFill>
              <a:srgbClr val="96969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708200" y="5084640"/>
            <a:ext cx="1797120" cy="627120"/>
          </a:xfrm>
          <a:custGeom>
            <a:avLst/>
            <a:gdLst/>
            <a:ahLst/>
            <a:rect l="l" t="t" r="r" b="b"/>
            <a:pathLst>
              <a:path w="5386" h="1876">
                <a:moveTo>
                  <a:pt x="0" y="1876"/>
                </a:moveTo>
                <a:lnTo>
                  <a:pt x="54" y="1631"/>
                </a:lnTo>
                <a:lnTo>
                  <a:pt x="109" y="1455"/>
                </a:lnTo>
                <a:lnTo>
                  <a:pt x="163" y="1305"/>
                </a:lnTo>
                <a:lnTo>
                  <a:pt x="218" y="1175"/>
                </a:lnTo>
                <a:lnTo>
                  <a:pt x="272" y="1048"/>
                </a:lnTo>
                <a:lnTo>
                  <a:pt x="326" y="961"/>
                </a:lnTo>
                <a:lnTo>
                  <a:pt x="381" y="888"/>
                </a:lnTo>
                <a:lnTo>
                  <a:pt x="435" y="830"/>
                </a:lnTo>
                <a:lnTo>
                  <a:pt x="490" y="755"/>
                </a:lnTo>
                <a:lnTo>
                  <a:pt x="544" y="683"/>
                </a:lnTo>
                <a:lnTo>
                  <a:pt x="598" y="612"/>
                </a:lnTo>
                <a:lnTo>
                  <a:pt x="652" y="558"/>
                </a:lnTo>
                <a:lnTo>
                  <a:pt x="707" y="513"/>
                </a:lnTo>
                <a:lnTo>
                  <a:pt x="762" y="467"/>
                </a:lnTo>
                <a:lnTo>
                  <a:pt x="816" y="434"/>
                </a:lnTo>
                <a:lnTo>
                  <a:pt x="870" y="404"/>
                </a:lnTo>
                <a:lnTo>
                  <a:pt x="924" y="380"/>
                </a:lnTo>
                <a:lnTo>
                  <a:pt x="979" y="350"/>
                </a:lnTo>
                <a:lnTo>
                  <a:pt x="1034" y="320"/>
                </a:lnTo>
                <a:lnTo>
                  <a:pt x="1088" y="292"/>
                </a:lnTo>
                <a:lnTo>
                  <a:pt x="1142" y="272"/>
                </a:lnTo>
                <a:lnTo>
                  <a:pt x="1196" y="257"/>
                </a:lnTo>
                <a:lnTo>
                  <a:pt x="1251" y="244"/>
                </a:lnTo>
                <a:lnTo>
                  <a:pt x="1306" y="235"/>
                </a:lnTo>
                <a:lnTo>
                  <a:pt x="1360" y="224"/>
                </a:lnTo>
                <a:lnTo>
                  <a:pt x="1414" y="211"/>
                </a:lnTo>
                <a:lnTo>
                  <a:pt x="1468" y="195"/>
                </a:lnTo>
                <a:lnTo>
                  <a:pt x="1523" y="187"/>
                </a:lnTo>
                <a:lnTo>
                  <a:pt x="1578" y="184"/>
                </a:lnTo>
                <a:lnTo>
                  <a:pt x="1632" y="178"/>
                </a:lnTo>
                <a:lnTo>
                  <a:pt x="1686" y="162"/>
                </a:lnTo>
                <a:lnTo>
                  <a:pt x="1740" y="141"/>
                </a:lnTo>
                <a:lnTo>
                  <a:pt x="1795" y="126"/>
                </a:lnTo>
                <a:lnTo>
                  <a:pt x="1850" y="124"/>
                </a:lnTo>
                <a:lnTo>
                  <a:pt x="1904" y="120"/>
                </a:lnTo>
                <a:lnTo>
                  <a:pt x="1958" y="114"/>
                </a:lnTo>
                <a:lnTo>
                  <a:pt x="2012" y="96"/>
                </a:lnTo>
                <a:lnTo>
                  <a:pt x="2067" y="85"/>
                </a:lnTo>
                <a:lnTo>
                  <a:pt x="2122" y="78"/>
                </a:lnTo>
                <a:lnTo>
                  <a:pt x="2176" y="81"/>
                </a:lnTo>
                <a:lnTo>
                  <a:pt x="2230" y="85"/>
                </a:lnTo>
                <a:lnTo>
                  <a:pt x="2284" y="78"/>
                </a:lnTo>
                <a:lnTo>
                  <a:pt x="2339" y="72"/>
                </a:lnTo>
                <a:lnTo>
                  <a:pt x="2394" y="62"/>
                </a:lnTo>
                <a:lnTo>
                  <a:pt x="2448" y="60"/>
                </a:lnTo>
                <a:lnTo>
                  <a:pt x="2502" y="56"/>
                </a:lnTo>
                <a:lnTo>
                  <a:pt x="2556" y="54"/>
                </a:lnTo>
                <a:lnTo>
                  <a:pt x="2611" y="48"/>
                </a:lnTo>
                <a:lnTo>
                  <a:pt x="2666" y="41"/>
                </a:lnTo>
                <a:lnTo>
                  <a:pt x="2720" y="35"/>
                </a:lnTo>
                <a:lnTo>
                  <a:pt x="2774" y="35"/>
                </a:lnTo>
                <a:lnTo>
                  <a:pt x="2828" y="39"/>
                </a:lnTo>
                <a:lnTo>
                  <a:pt x="2883" y="39"/>
                </a:lnTo>
                <a:lnTo>
                  <a:pt x="2938" y="35"/>
                </a:lnTo>
                <a:lnTo>
                  <a:pt x="2992" y="29"/>
                </a:lnTo>
                <a:lnTo>
                  <a:pt x="3046" y="27"/>
                </a:lnTo>
                <a:lnTo>
                  <a:pt x="3100" y="23"/>
                </a:lnTo>
                <a:lnTo>
                  <a:pt x="3155" y="23"/>
                </a:lnTo>
                <a:lnTo>
                  <a:pt x="3210" y="23"/>
                </a:lnTo>
                <a:lnTo>
                  <a:pt x="3264" y="27"/>
                </a:lnTo>
                <a:lnTo>
                  <a:pt x="3318" y="23"/>
                </a:lnTo>
                <a:lnTo>
                  <a:pt x="3372" y="21"/>
                </a:lnTo>
                <a:lnTo>
                  <a:pt x="3427" y="18"/>
                </a:lnTo>
                <a:lnTo>
                  <a:pt x="3482" y="18"/>
                </a:lnTo>
                <a:lnTo>
                  <a:pt x="3536" y="18"/>
                </a:lnTo>
                <a:lnTo>
                  <a:pt x="3590" y="18"/>
                </a:lnTo>
                <a:lnTo>
                  <a:pt x="3644" y="14"/>
                </a:lnTo>
                <a:lnTo>
                  <a:pt x="3699" y="14"/>
                </a:lnTo>
                <a:lnTo>
                  <a:pt x="3754" y="12"/>
                </a:lnTo>
                <a:lnTo>
                  <a:pt x="3808" y="12"/>
                </a:lnTo>
                <a:lnTo>
                  <a:pt x="3862" y="12"/>
                </a:lnTo>
                <a:lnTo>
                  <a:pt x="3916" y="12"/>
                </a:lnTo>
                <a:lnTo>
                  <a:pt x="3970" y="8"/>
                </a:lnTo>
                <a:lnTo>
                  <a:pt x="4026" y="6"/>
                </a:lnTo>
                <a:lnTo>
                  <a:pt x="4080" y="6"/>
                </a:lnTo>
                <a:lnTo>
                  <a:pt x="4134" y="6"/>
                </a:lnTo>
                <a:lnTo>
                  <a:pt x="4188" y="6"/>
                </a:lnTo>
                <a:lnTo>
                  <a:pt x="4242" y="6"/>
                </a:lnTo>
                <a:lnTo>
                  <a:pt x="4298" y="2"/>
                </a:lnTo>
                <a:lnTo>
                  <a:pt x="4352" y="2"/>
                </a:lnTo>
                <a:lnTo>
                  <a:pt x="4406" y="2"/>
                </a:lnTo>
                <a:lnTo>
                  <a:pt x="4460" y="6"/>
                </a:lnTo>
                <a:lnTo>
                  <a:pt x="4514" y="6"/>
                </a:lnTo>
                <a:lnTo>
                  <a:pt x="4570" y="2"/>
                </a:lnTo>
                <a:lnTo>
                  <a:pt x="4624" y="2"/>
                </a:lnTo>
                <a:lnTo>
                  <a:pt x="4678" y="2"/>
                </a:lnTo>
                <a:lnTo>
                  <a:pt x="4732" y="2"/>
                </a:lnTo>
                <a:lnTo>
                  <a:pt x="4786" y="6"/>
                </a:lnTo>
                <a:lnTo>
                  <a:pt x="4842" y="2"/>
                </a:lnTo>
                <a:lnTo>
                  <a:pt x="4896" y="2"/>
                </a:lnTo>
                <a:lnTo>
                  <a:pt x="4950" y="0"/>
                </a:lnTo>
                <a:lnTo>
                  <a:pt x="5004" y="2"/>
                </a:lnTo>
                <a:lnTo>
                  <a:pt x="5058" y="2"/>
                </a:lnTo>
                <a:lnTo>
                  <a:pt x="5114" y="0"/>
                </a:lnTo>
                <a:lnTo>
                  <a:pt x="5168" y="0"/>
                </a:lnTo>
                <a:lnTo>
                  <a:pt x="5222" y="0"/>
                </a:lnTo>
                <a:lnTo>
                  <a:pt x="5276" y="0"/>
                </a:lnTo>
                <a:lnTo>
                  <a:pt x="5330" y="0"/>
                </a:lnTo>
                <a:lnTo>
                  <a:pt x="5386" y="0"/>
                </a:lnTo>
              </a:path>
            </a:pathLst>
          </a:custGeom>
          <a:noFill/>
          <a:ln w="19080">
            <a:solidFill>
              <a:srgbClr val="00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1720800" y="2519280"/>
            <a:ext cx="725400" cy="417600"/>
          </a:xfrm>
          <a:custGeom>
            <a:avLst/>
            <a:gdLst/>
            <a:ahLst/>
            <a:rect l="l" t="t" r="r" b="b"/>
            <a:pathLst>
              <a:path w="2176" h="1248">
                <a:moveTo>
                  <a:pt x="0" y="1248"/>
                </a:moveTo>
                <a:lnTo>
                  <a:pt x="54" y="1202"/>
                </a:lnTo>
                <a:lnTo>
                  <a:pt x="108" y="1136"/>
                </a:lnTo>
                <a:lnTo>
                  <a:pt x="163" y="1061"/>
                </a:lnTo>
                <a:lnTo>
                  <a:pt x="218" y="1001"/>
                </a:lnTo>
                <a:lnTo>
                  <a:pt x="272" y="953"/>
                </a:lnTo>
                <a:lnTo>
                  <a:pt x="326" y="907"/>
                </a:lnTo>
                <a:lnTo>
                  <a:pt x="380" y="862"/>
                </a:lnTo>
                <a:lnTo>
                  <a:pt x="435" y="810"/>
                </a:lnTo>
                <a:lnTo>
                  <a:pt x="490" y="770"/>
                </a:lnTo>
                <a:lnTo>
                  <a:pt x="544" y="719"/>
                </a:lnTo>
                <a:lnTo>
                  <a:pt x="598" y="668"/>
                </a:lnTo>
                <a:lnTo>
                  <a:pt x="652" y="619"/>
                </a:lnTo>
                <a:lnTo>
                  <a:pt x="707" y="596"/>
                </a:lnTo>
                <a:lnTo>
                  <a:pt x="762" y="575"/>
                </a:lnTo>
                <a:lnTo>
                  <a:pt x="816" y="548"/>
                </a:lnTo>
                <a:lnTo>
                  <a:pt x="870" y="502"/>
                </a:lnTo>
                <a:lnTo>
                  <a:pt x="924" y="463"/>
                </a:lnTo>
                <a:lnTo>
                  <a:pt x="979" y="442"/>
                </a:lnTo>
                <a:lnTo>
                  <a:pt x="1034" y="430"/>
                </a:lnTo>
                <a:lnTo>
                  <a:pt x="1088" y="417"/>
                </a:lnTo>
                <a:lnTo>
                  <a:pt x="1142" y="399"/>
                </a:lnTo>
                <a:lnTo>
                  <a:pt x="1196" y="369"/>
                </a:lnTo>
                <a:lnTo>
                  <a:pt x="1251" y="332"/>
                </a:lnTo>
                <a:lnTo>
                  <a:pt x="1306" y="287"/>
                </a:lnTo>
                <a:lnTo>
                  <a:pt x="1360" y="245"/>
                </a:lnTo>
                <a:lnTo>
                  <a:pt x="1414" y="208"/>
                </a:lnTo>
                <a:lnTo>
                  <a:pt x="1468" y="181"/>
                </a:lnTo>
                <a:lnTo>
                  <a:pt x="1523" y="164"/>
                </a:lnTo>
                <a:lnTo>
                  <a:pt x="1578" y="142"/>
                </a:lnTo>
                <a:lnTo>
                  <a:pt x="1632" y="131"/>
                </a:lnTo>
                <a:lnTo>
                  <a:pt x="1686" y="118"/>
                </a:lnTo>
                <a:lnTo>
                  <a:pt x="1740" y="124"/>
                </a:lnTo>
                <a:lnTo>
                  <a:pt x="1795" y="118"/>
                </a:lnTo>
                <a:lnTo>
                  <a:pt x="1850" y="97"/>
                </a:lnTo>
                <a:lnTo>
                  <a:pt x="1904" y="48"/>
                </a:lnTo>
                <a:lnTo>
                  <a:pt x="1958" y="21"/>
                </a:lnTo>
                <a:lnTo>
                  <a:pt x="2012" y="12"/>
                </a:lnTo>
                <a:lnTo>
                  <a:pt x="2067" y="19"/>
                </a:lnTo>
                <a:lnTo>
                  <a:pt x="2122" y="12"/>
                </a:lnTo>
                <a:lnTo>
                  <a:pt x="2176" y="0"/>
                </a:lnTo>
              </a:path>
            </a:pathLst>
          </a:custGeom>
          <a:noFill/>
          <a:ln w="19080">
            <a:solidFill>
              <a:srgbClr val="ff33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1569600" y="15350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1416960" y="50976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1569600" y="32130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1416960" y="218448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1569600" y="4702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1416960" y="367524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1642680" y="61898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1960200" y="618984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2323800" y="618984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2687400" y="618984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3050640" y="618984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366360" y="618984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1569600" y="60674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1416960" y="504360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1943280" y="6446880"/>
            <a:ext cx="1309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mber of neuro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 rot="16200000">
            <a:off x="154080" y="985320"/>
            <a:ext cx="184788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ercent correc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eural estim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3817800" y="5292720"/>
            <a:ext cx="100044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ll spatially tuned neuro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3840120" y="3913200"/>
            <a:ext cx="954000" cy="54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eurons tuned to both locatio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973680" y="635040"/>
            <a:ext cx="688680" cy="73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eurons tuned to attended loc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3753000" y="2448000"/>
            <a:ext cx="1131840" cy="54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eurons tuned to remembered loc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542880" y="52848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549360" y="195588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542880" y="359424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544320" y="503064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5027760" y="3124080"/>
            <a:ext cx="1409400" cy="1886040"/>
          </a:xfrm>
          <a:prstGeom prst="rect">
            <a:avLst/>
          </a:prstGeom>
          <a:solidFill>
            <a:srgbClr val="dddd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5141880" y="4238640"/>
            <a:ext cx="236520" cy="0"/>
          </a:xfrm>
          <a:prstGeom prst="line">
            <a:avLst/>
          </a:prstGeom>
          <a:ln w="19080">
            <a:solidFill>
              <a:srgbClr val="ff5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5141880" y="3816360"/>
            <a:ext cx="236520" cy="0"/>
          </a:xfrm>
          <a:prstGeom prst="line">
            <a:avLst/>
          </a:prstGeom>
          <a:ln w="19080">
            <a:solidFill>
              <a:srgbClr val="00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5145120" y="4678200"/>
            <a:ext cx="233280" cy="0"/>
          </a:xfrm>
          <a:prstGeom prst="line">
            <a:avLst/>
          </a:prstGeom>
          <a:ln w="19080">
            <a:solidFill>
              <a:srgbClr val="96969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5421960" y="3571920"/>
            <a:ext cx="837360" cy="123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ttended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ocat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emembered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ocat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ocation befor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ircle movemen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5085360" y="3371760"/>
            <a:ext cx="1145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 u="sng">
                <a:solidFill>
                  <a:srgbClr val="000000"/>
                </a:solidFill>
                <a:uFillTx/>
                <a:latin typeface="Arial"/>
              </a:rPr>
              <a:t>Neural estimate of: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731880" y="7180200"/>
            <a:ext cx="51148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r" pos="228600"/>
                <a:tab algn="r" pos="343080"/>
                <a:tab algn="l" pos="457200"/>
                <a:tab algn="l" pos="1714680"/>
                <a:tab algn="ctr" pos="2743200"/>
                <a:tab algn="l" pos="5200560"/>
                <a:tab algn="r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7.  Neuron-dropping curves for the two monkeys combine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r" pos="228600"/>
                <a:tab algn="r" pos="343080"/>
                <a:tab algn="l" pos="457200"/>
                <a:tab algn="l" pos="1714680"/>
                <a:tab algn="ctr" pos="2743200"/>
                <a:tab algn="l" pos="5200560"/>
                <a:tab algn="r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r" pos="228600"/>
                <a:tab algn="r" pos="343080"/>
                <a:tab algn="l" pos="457200"/>
                <a:tab algn="l" pos="1714680"/>
                <a:tab algn="ctr" pos="2743200"/>
                <a:tab algn="l" pos="5200560"/>
                <a:tab algn="r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ormat as in Figure 7A-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r" pos="228600"/>
                <a:tab algn="r" pos="343080"/>
                <a:tab algn="l" pos="457200"/>
                <a:tab algn="l" pos="1714680"/>
                <a:tab algn="ctr" pos="2743200"/>
                <a:tab algn="l" pos="5200560"/>
                <a:tab algn="r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1698480" y="4486320"/>
            <a:ext cx="179712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1701720" y="5851440"/>
            <a:ext cx="179712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1711440" y="3025800"/>
            <a:ext cx="179676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1695600" y="1305000"/>
            <a:ext cx="179676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9-08T19:44:15Z</dcterms:created>
  <dc:creator>Chelsea Scholl</dc:creator>
  <dc:description/>
  <dc:language>en-US</dc:language>
  <cp:lastModifiedBy>Chelsea Scholl</cp:lastModifiedBy>
  <dcterms:modified xsi:type="dcterms:W3CDTF">2004-09-08T19:46:40Z</dcterms:modified>
  <cp:revision>5</cp:revision>
  <dc:subject/>
  <dc:title>Slide 1</dc:title>
</cp:coreProperties>
</file>